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774"/>
  </p:normalViewPr>
  <p:slideViewPr>
    <p:cSldViewPr snapToGrid="0">
      <p:cViewPr varScale="1">
        <p:scale>
          <a:sx n="116" d="100"/>
          <a:sy n="116" d="100"/>
        </p:scale>
        <p:origin x="6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D11DA-ED06-580C-FF23-78913876D9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77B2E4-DFF4-ECD3-BD3E-21CFF3032E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3E014C-428D-DD6C-19E0-2773DE7B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7ED30-B020-7ADB-39E3-6E59522ED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B28BBD-16A7-C420-78DA-30A96B3AC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64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6F488-1EEA-1D65-8E32-29CAF5B33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276762-1DA9-34B6-891B-F77EC3C971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02E8E-FFF1-1DBC-330B-991C7A11F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4D720A-3883-9634-7C23-3CB47EA8C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E4AFE-90A6-BCFE-3F4B-ECB08CA03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951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12D35E-86C2-38AA-3663-D51ED870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AABA56-952C-F632-A4C1-AAF9045F45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A7BED-77BF-30F4-04AF-CE60711EF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022794-E7AA-5F9F-16A4-D8678E408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4E703A-9FB9-7AF2-10E8-03EE56F2A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038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B82C9-27ED-21DC-2496-CDFDF1901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8857C-D8B0-04C9-EC8D-F396292CE7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EFE3C0-CEC1-9463-F246-B5D7EEFA1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00AA96-1358-8316-E40A-43FE2AEB2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7E639-8B62-C2B8-207F-6E3C8A4BD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805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CF8785-8251-37F0-F587-F745C251A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D502A6-C6DF-5D21-FB9C-CDE62DA21A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F515F-61F0-060F-6487-BCF16814C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D4A6A6-FAA2-BEE8-29C2-9B0CA93B9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208A33-8158-DD50-90F6-C3DA97306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346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2A8F2-E4E0-AAE0-A421-582AB7BB7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544895-1AEA-F935-8471-CFADD4B606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89777D-1B8A-9D85-F5C5-73844DA562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5FE13A-5360-5DED-1700-79DD949DD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F71B60-7206-58D0-2D15-229FCA35A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8A23BD-F0F2-9504-EEEC-BAEC47832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923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D6EE8-30C4-E4BD-B2FB-EE8EF0DAA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E3198B-566E-E96C-5483-2C25528E61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4528BE-3E06-E01F-0EB4-91D40AE3DD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B33B58-7332-3795-1C12-D6F220479C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CE7E894-767A-25FE-0D98-2D07070780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402F91-DB36-A260-B49D-F6960BDCF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FDCB82-E34D-789E-5ED6-51A57BE88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04A8E0-E9CA-70FB-4A6E-3DA3D6640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126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7B01E2-8914-E7B8-C42A-C60A8744B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F58D65-266C-1E11-6C08-6FD8D1A76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D39F3A-7D59-54C0-5C25-E13AD37E8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747288-004A-FA83-7114-607D7F2C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166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6D4533-520B-0AB9-AA35-DA754516C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D8721D-0154-CC57-9D14-287551393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4963C3-C0A8-F656-BC92-3460DE877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975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EF331-A3F1-253B-DDCE-0F9B4674F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4F0F6E-58A8-EB07-0A2A-CB5C764390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9E81B8-39E7-2246-9AE8-933BFB1B8B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CF8C32-7B6C-0F29-5CED-F6B76AF80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DC8717-C5B1-8633-68E7-4D5C5441A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A430A0-0FA4-A228-E61B-C3FFCF890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90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F1EF5-99E9-D5B4-19FD-AAA266C25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A6CDB3-8A7C-BCF6-9B76-5FA0C437AB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08F459-8C4D-C914-B603-A13B791C87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FEA0B6-32E2-D997-16CE-1E03AA32C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5B3C40-6022-8EFF-E2D0-C831B4A86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4A86B8-A5BF-9241-8330-98BD858DE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15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58A2DE-68A6-8E60-C415-BD9583721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4AA521-5E5E-339B-7391-2BBEB2A7C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A6D1E-E4EF-3773-EEEE-758E3CCB65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DD29C-0F48-5347-8CA4-FB57A031618B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B43F5-4508-EF67-4632-CFE68B847E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BC5D42-1D3B-FC9F-0A72-C381AE434B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5FAAA-7DAE-824E-A551-2916D7C09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7F0EF68-AA21-0242-94ED-9FE9483B70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3461871"/>
              </p:ext>
            </p:extLst>
          </p:nvPr>
        </p:nvGraphicFramePr>
        <p:xfrm>
          <a:off x="319585" y="339635"/>
          <a:ext cx="10509528" cy="642186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75794">
                  <a:extLst>
                    <a:ext uri="{9D8B030D-6E8A-4147-A177-3AD203B41FA5}">
                      <a16:colId xmlns:a16="http://schemas.microsoft.com/office/drawing/2014/main" val="1299851226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645720552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418083782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2396595301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2082622275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59844117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71609221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926809518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2702867514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449584147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3995058393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540001235"/>
                    </a:ext>
                  </a:extLst>
                </a:gridCol>
              </a:tblGrid>
              <a:tr h="113978">
                <a:tc gridSpan="1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Med ID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935684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739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507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192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397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903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648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735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234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047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481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981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0140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44122723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08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561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314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560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242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016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394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727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266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481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8828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0920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523849896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08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679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455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845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233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515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578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871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516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481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9702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362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522065412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59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819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534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568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724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866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828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042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235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167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0745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548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706270829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03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051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534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278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013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806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935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355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337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662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626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639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858204528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640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717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748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757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091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900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935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659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338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885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919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675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366730954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307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717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517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826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167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072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411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114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259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885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695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917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88567385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796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708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721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024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167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337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748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233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697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344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846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3154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602176926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213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566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721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099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513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209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748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233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902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559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263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5670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715044484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348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77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863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411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626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089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121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428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353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559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263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6190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03581714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696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262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990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631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677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204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277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658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1048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798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481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6451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508969538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23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510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990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631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843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287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466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873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122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029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375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8522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12380716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24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242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051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781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068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671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702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873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656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029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493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960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266167008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252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518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573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255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327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873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009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176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782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547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909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960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637853095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646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887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912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407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487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296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303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392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245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994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883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960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294360334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115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887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965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579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638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977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784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023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245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394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883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960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312821570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458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009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965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737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794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584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170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242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417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654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991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1882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393879648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948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009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464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737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626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268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686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414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598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654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991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128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53523341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380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156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749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882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720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489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687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881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956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175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991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687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93139222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782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156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093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171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273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657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858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881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247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175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430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954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546813670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239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156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459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905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502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960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858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348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247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400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744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213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08433072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312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684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515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905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681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76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039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491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502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441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001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495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58543552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160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025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200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386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565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76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605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720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142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442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248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495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90746853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160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300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200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386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883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69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794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933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142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705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397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4344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79975026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160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916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472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431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209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33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981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130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776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874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4818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4605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62533873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459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295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617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682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210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996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070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596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059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602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940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624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68879384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19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428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763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389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513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996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156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6332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122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7587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941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8473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93133247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19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554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944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583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513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996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156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6404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672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346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8535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8830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853749475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82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335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436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703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676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512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530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6855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672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346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8584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9073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626835265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424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123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518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046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973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685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645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026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924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564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300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816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89660316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977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257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617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186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198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215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7524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026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102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564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5475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612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180649720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977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636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877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555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596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482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9597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233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102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792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703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513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23020669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257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814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032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727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998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512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959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449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102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0624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914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091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12947649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257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385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032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037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176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512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959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662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0885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0625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127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092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87327741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4708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567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450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474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17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712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160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887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120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0625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093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55613575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682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070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3048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636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630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8907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237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141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2291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0625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434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96067477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5766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391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395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636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698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970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611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253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044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268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558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53785482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576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518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606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636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880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059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823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419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277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538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365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435175354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712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880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672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721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871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214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836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464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4975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3026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432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4161504306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811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598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696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041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871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301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837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876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430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083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155498744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979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964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865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203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020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478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426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876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648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734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542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847334385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979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785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937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381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247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478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4261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9501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648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734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674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412910711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979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785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307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428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457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478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160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9902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6817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734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866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4254000548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014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971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736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464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888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663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160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9902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71568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734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867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427636516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058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052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805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464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888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749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395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148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7690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48739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870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605384219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428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4286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850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633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888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307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563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1150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005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226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870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772195293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428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773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971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7875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570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882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808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348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005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462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262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3553824987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842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0854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104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331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959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124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808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4363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219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963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510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87991559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842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085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104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002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959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334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284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4363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219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963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7867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/>
                </a:tc>
                <a:extLst>
                  <a:ext uri="{0D108BD9-81ED-4DB2-BD59-A6C34878D82A}">
                    <a16:rowId xmlns:a16="http://schemas.microsoft.com/office/drawing/2014/main" val="240950751"/>
                  </a:ext>
                </a:extLst>
              </a:tr>
              <a:tr h="1139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842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139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243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903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648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520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525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047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219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422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8940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999" marR="3999" marT="39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010503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C8617F6-4922-EB40-B85D-7E627ED10CC6}"/>
              </a:ext>
            </a:extLst>
          </p:cNvPr>
          <p:cNvSpPr txBox="1"/>
          <p:nvPr/>
        </p:nvSpPr>
        <p:spPr>
          <a:xfrm>
            <a:off x="236483" y="62636"/>
            <a:ext cx="8103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PubMed Identifiers (PMIDs) for manuscripts extracted for the creation of the database.</a:t>
            </a:r>
          </a:p>
        </p:txBody>
      </p:sp>
    </p:spTree>
    <p:extLst>
      <p:ext uri="{BB962C8B-B14F-4D97-AF65-F5344CB8AC3E}">
        <p14:creationId xmlns:p14="http://schemas.microsoft.com/office/powerpoint/2010/main" val="4010208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611</Words>
  <Application>Microsoft Macintosh PowerPoint</Application>
  <PresentationFormat>Widescreen</PresentationFormat>
  <Paragraphs>5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ua Beckman</dc:creator>
  <cp:lastModifiedBy>Xiang, Rachel (NIH/NCI) [F]</cp:lastModifiedBy>
  <cp:revision>9</cp:revision>
  <cp:lastPrinted>2023-08-30T01:39:00Z</cp:lastPrinted>
  <dcterms:created xsi:type="dcterms:W3CDTF">2023-08-16T14:34:38Z</dcterms:created>
  <dcterms:modified xsi:type="dcterms:W3CDTF">2023-09-01T13:56:26Z</dcterms:modified>
</cp:coreProperties>
</file>